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media/image8.jpeg" ContentType="image/jpeg"/>
  <Override PartName="/ppt/media/image13.jpeg" ContentType="image/jpeg"/>
  <Override PartName="/ppt/media/image9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834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83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8296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97360" y="0"/>
            <a:ext cx="298296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17440" y="696960"/>
            <a:ext cx="46483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2520" rIns="9252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8680" y="4416120"/>
            <a:ext cx="5505480" cy="418284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298296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97360" y="8829720"/>
            <a:ext cx="2982960" cy="46512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720773-8890-407A-B9D5-5F2D255873D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111744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8680" y="4416120"/>
            <a:ext cx="550548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lide Number Placeholder 3"/>
          <p:cNvSpPr/>
          <p:nvPr/>
        </p:nvSpPr>
        <p:spPr>
          <a:xfrm>
            <a:off x="3897360" y="8829720"/>
            <a:ext cx="298296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080" bIns="460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35E17F-2B7B-4E59-B66D-A954B40F65E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DA5BC-3764-4A32-BAD3-C8DA910C8D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6908F-7E82-4B51-8E11-E054B205EE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E825E-C35C-4739-8A09-4AB5BDD4DE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97CCE-0B47-416B-B9E3-04A1C9E02F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C1BC7-E708-4AD9-A972-E126AD03F5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9F17F-C634-46A8-BDB8-11B2BC6828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BB9887-4371-4A82-9714-0AB76F1C62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37790-2A13-4FC3-B8A7-56A0CD0483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00F62-FE27-4AAB-90F2-B5A1088E4D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05C3D6-DC4E-4368-A7CD-F10F4BB990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61A8F-3862-4D55-B56E-EF1B98C5F5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4D140-4701-4D88-ACB8-68230F9F85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484E66-FAF0-4106-915C-B0EE76F8B3B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4.jpeg"/><Relationship Id="rId13" Type="http://schemas.openxmlformats.org/officeDocument/2006/relationships/image" Target="../media/image5.jpeg"/><Relationship Id="rId14" Type="http://schemas.openxmlformats.org/officeDocument/2006/relationships/image" Target="../media/image12.jpeg"/><Relationship Id="rId15" Type="http://schemas.openxmlformats.org/officeDocument/2006/relationships/image" Target="../media/image13.jpeg"/><Relationship Id="rId16" Type="http://schemas.openxmlformats.org/officeDocument/2006/relationships/image" Target="../media/image8.jpe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"/>
          <p:cNvGrpSpPr/>
          <p:nvPr/>
        </p:nvGrpSpPr>
        <p:grpSpPr>
          <a:xfrm>
            <a:off x="3027240" y="2392200"/>
            <a:ext cx="1712880" cy="2719080"/>
            <a:chOff x="3027240" y="2392200"/>
            <a:chExt cx="1712880" cy="2719080"/>
          </a:xfrm>
        </p:grpSpPr>
        <p:sp>
          <p:nvSpPr>
            <p:cNvPr id="49" name="TextBox 116"/>
            <p:cNvSpPr/>
            <p:nvPr/>
          </p:nvSpPr>
          <p:spPr>
            <a:xfrm>
              <a:off x="3175560" y="4834800"/>
              <a:ext cx="13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Mature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17"/>
            <p:cNvSpPr/>
            <p:nvPr/>
          </p:nvSpPr>
          <p:spPr>
            <a:xfrm>
              <a:off x="3175560" y="4224240"/>
              <a:ext cx="13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6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18"/>
            <p:cNvSpPr/>
            <p:nvPr/>
          </p:nvSpPr>
          <p:spPr>
            <a:xfrm>
              <a:off x="3175560" y="3624120"/>
              <a:ext cx="13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8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19"/>
            <p:cNvSpPr/>
            <p:nvPr/>
          </p:nvSpPr>
          <p:spPr>
            <a:xfrm>
              <a:off x="3175560" y="3002760"/>
              <a:ext cx="13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11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20"/>
            <p:cNvSpPr/>
            <p:nvPr/>
          </p:nvSpPr>
          <p:spPr>
            <a:xfrm>
              <a:off x="3027240" y="2392200"/>
              <a:ext cx="1712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18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4" name="Group 2"/>
          <p:cNvGrpSpPr/>
          <p:nvPr/>
        </p:nvGrpSpPr>
        <p:grpSpPr>
          <a:xfrm>
            <a:off x="3978360" y="2401920"/>
            <a:ext cx="1303200" cy="2717280"/>
            <a:chOff x="3978360" y="2401920"/>
            <a:chExt cx="1303200" cy="2717280"/>
          </a:xfrm>
        </p:grpSpPr>
        <p:sp>
          <p:nvSpPr>
            <p:cNvPr id="55" name="TextBox 112"/>
            <p:cNvSpPr/>
            <p:nvPr/>
          </p:nvSpPr>
          <p:spPr>
            <a:xfrm>
              <a:off x="3978360" y="4232520"/>
              <a:ext cx="13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6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13"/>
            <p:cNvSpPr/>
            <p:nvPr/>
          </p:nvSpPr>
          <p:spPr>
            <a:xfrm>
              <a:off x="3978360" y="3643560"/>
              <a:ext cx="13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9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14"/>
            <p:cNvSpPr/>
            <p:nvPr/>
          </p:nvSpPr>
          <p:spPr>
            <a:xfrm>
              <a:off x="3978360" y="3012120"/>
              <a:ext cx="13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11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15"/>
            <p:cNvSpPr/>
            <p:nvPr/>
          </p:nvSpPr>
          <p:spPr>
            <a:xfrm>
              <a:off x="3978360" y="2401920"/>
              <a:ext cx="13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-17 day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21"/>
            <p:cNvSpPr/>
            <p:nvPr/>
          </p:nvSpPr>
          <p:spPr>
            <a:xfrm>
              <a:off x="3978360" y="4842720"/>
              <a:ext cx="13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Mature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0" name="Picture 4" descr="C:\Users\wolfe\Desktop\10_22_2010 PI 84970 black seeds collection.jpg"/>
          <p:cNvPicPr/>
          <p:nvPr/>
        </p:nvPicPr>
        <p:blipFill>
          <a:blip r:embed="rId1"/>
          <a:srcRect l="0" t="46259" r="36428" b="17508"/>
          <a:stretch/>
        </p:blipFill>
        <p:spPr>
          <a:xfrm>
            <a:off x="5183280" y="2106720"/>
            <a:ext cx="2052720" cy="69840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4" descr="C:\Users\wolfe\Desktop\R gene paper\11_07_2010 PI 84970 black seeds collection.jpg"/>
          <p:cNvPicPr/>
          <p:nvPr/>
        </p:nvPicPr>
        <p:blipFill>
          <a:blip r:embed="rId2"/>
          <a:srcRect l="9591" t="0" r="3699" b="60977"/>
          <a:stretch/>
        </p:blipFill>
        <p:spPr>
          <a:xfrm>
            <a:off x="5183280" y="3500280"/>
            <a:ext cx="2052720" cy="5526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3" descr="C:\Users\wolfe\Desktop\R gene paper\11_05_2010 PI 84970 black seeds collection.jpg"/>
          <p:cNvPicPr/>
          <p:nvPr/>
        </p:nvPicPr>
        <p:blipFill>
          <a:blip r:embed="rId3"/>
          <a:srcRect l="3244" t="0" r="74168" b="52703"/>
          <a:stretch/>
        </p:blipFill>
        <p:spPr>
          <a:xfrm>
            <a:off x="5183280" y="2874960"/>
            <a:ext cx="960480" cy="55404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109" descr="11_10_2010 PI 84970 black seeds collection.jpg"/>
          <p:cNvPicPr/>
          <p:nvPr/>
        </p:nvPicPr>
        <p:blipFill>
          <a:blip r:embed="rId4"/>
          <a:srcRect l="58114" t="7283" r="3217" b="59104"/>
          <a:stretch/>
        </p:blipFill>
        <p:spPr>
          <a:xfrm>
            <a:off x="6165720" y="4122720"/>
            <a:ext cx="1070280" cy="49536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111" descr="11_16_2010 PI 84970 black seeds collection.jpg"/>
          <p:cNvPicPr/>
          <p:nvPr/>
        </p:nvPicPr>
        <p:blipFill>
          <a:blip r:embed="rId5"/>
          <a:srcRect l="61301" t="10159" r="706" b="57755"/>
          <a:stretch/>
        </p:blipFill>
        <p:spPr>
          <a:xfrm>
            <a:off x="6500880" y="4708440"/>
            <a:ext cx="735120" cy="509760"/>
          </a:xfrm>
          <a:prstGeom prst="rect">
            <a:avLst/>
          </a:prstGeom>
          <a:ln w="0">
            <a:noFill/>
          </a:ln>
        </p:spPr>
      </p:pic>
      <p:sp>
        <p:nvSpPr>
          <p:cNvPr id="65" name="TextBox 122"/>
          <p:cNvSpPr/>
          <p:nvPr/>
        </p:nvSpPr>
        <p:spPr>
          <a:xfrm>
            <a:off x="4940280" y="1743120"/>
            <a:ext cx="250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I 84970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2" descr="C:\Users\wolfe\Desktop\11_03_2010 PI 567115 B brown seeds collection.jpg"/>
          <p:cNvPicPr/>
          <p:nvPr/>
        </p:nvPicPr>
        <p:blipFill>
          <a:blip r:embed="rId6"/>
          <a:srcRect l="5891" t="4524" r="38387" b="55923"/>
          <a:stretch/>
        </p:blipFill>
        <p:spPr>
          <a:xfrm>
            <a:off x="1770120" y="4097160"/>
            <a:ext cx="1716120" cy="47952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3" descr="C:\Users\wolfe\Desktop\10_22_2010 PI 567115 B brown seeds collection.jpg"/>
          <p:cNvPicPr/>
          <p:nvPr/>
        </p:nvPicPr>
        <p:blipFill>
          <a:blip r:embed="rId7"/>
          <a:srcRect l="25945" t="41520" r="52889" b="21689"/>
          <a:stretch/>
        </p:blipFill>
        <p:spPr>
          <a:xfrm>
            <a:off x="2897280" y="2106720"/>
            <a:ext cx="588960" cy="55080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5" descr="C:\Users\wolfe\Desktop\10_29_2010 PI 567115 B brown seeds collection.jpg"/>
          <p:cNvPicPr/>
          <p:nvPr/>
        </p:nvPicPr>
        <p:blipFill>
          <a:blip r:embed="rId8"/>
          <a:srcRect l="45232" t="14122" r="24423" b="48362"/>
          <a:stretch/>
        </p:blipFill>
        <p:spPr>
          <a:xfrm>
            <a:off x="1770120" y="2792520"/>
            <a:ext cx="762120" cy="5317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3" descr="C:\Users\wolfe\Desktop\11_01_2010 PI 567115 B brown seeds collection.jpg"/>
          <p:cNvPicPr/>
          <p:nvPr/>
        </p:nvPicPr>
        <p:blipFill>
          <a:blip r:embed="rId9"/>
          <a:srcRect l="38807" t="0" r="37601" b="61727"/>
          <a:stretch/>
        </p:blipFill>
        <p:spPr>
          <a:xfrm>
            <a:off x="2673360" y="3460680"/>
            <a:ext cx="812880" cy="5018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124" descr="11_09_2010 PI 567115 B brown seeds collection.jpg"/>
          <p:cNvPicPr/>
          <p:nvPr/>
        </p:nvPicPr>
        <p:blipFill>
          <a:blip r:embed="rId10"/>
          <a:srcRect l="226" t="8966" r="28015" b="56769"/>
          <a:stretch/>
        </p:blipFill>
        <p:spPr>
          <a:xfrm>
            <a:off x="1770120" y="4713120"/>
            <a:ext cx="1716120" cy="486000"/>
          </a:xfrm>
          <a:prstGeom prst="rect">
            <a:avLst/>
          </a:prstGeom>
          <a:ln w="0">
            <a:noFill/>
          </a:ln>
        </p:spPr>
      </p:pic>
      <p:sp>
        <p:nvSpPr>
          <p:cNvPr id="71" name="TextBox 123"/>
          <p:cNvSpPr/>
          <p:nvPr/>
        </p:nvSpPr>
        <p:spPr>
          <a:xfrm>
            <a:off x="1368360" y="1751040"/>
            <a:ext cx="250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I 567115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6"/>
          <p:cNvSpPr/>
          <p:nvPr/>
        </p:nvSpPr>
        <p:spPr>
          <a:xfrm>
            <a:off x="3486240" y="1531800"/>
            <a:ext cx="15080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llection date, measured in days before maturit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3" descr="C:\Users\wolfe\Desktop\R gene paper\11_05_2010 PI 84970 black seeds collection.jpg"/>
          <p:cNvPicPr/>
          <p:nvPr/>
        </p:nvPicPr>
        <p:blipFill>
          <a:blip r:embed="rId11"/>
          <a:srcRect l="48473" t="0" r="32597" b="52703"/>
          <a:stretch/>
        </p:blipFill>
        <p:spPr>
          <a:xfrm>
            <a:off x="6431040" y="2874960"/>
            <a:ext cx="804960" cy="55548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109" descr="11_10_2010 PI 84970 black seeds collection.jpg"/>
          <p:cNvPicPr/>
          <p:nvPr/>
        </p:nvPicPr>
        <p:blipFill>
          <a:blip r:embed="rId12"/>
          <a:srcRect l="4975" t="7283" r="61201" b="59104"/>
          <a:stretch/>
        </p:blipFill>
        <p:spPr>
          <a:xfrm>
            <a:off x="5183280" y="4122720"/>
            <a:ext cx="934920" cy="49536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111" descr="11_16_2010 PI 84970 black seeds collection.jpg"/>
          <p:cNvPicPr/>
          <p:nvPr/>
        </p:nvPicPr>
        <p:blipFill>
          <a:blip r:embed="rId13"/>
          <a:srcRect l="21413" t="10159" r="38717" b="57755"/>
          <a:stretch/>
        </p:blipFill>
        <p:spPr>
          <a:xfrm>
            <a:off x="5183280" y="4708440"/>
            <a:ext cx="772920" cy="50976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" descr="C:\Users\wolfe\Desktop\11_01_2010 PI 567115 B brown seeds collection.jpg"/>
          <p:cNvPicPr/>
          <p:nvPr/>
        </p:nvPicPr>
        <p:blipFill>
          <a:blip r:embed="rId14"/>
          <a:srcRect l="6000" t="0" r="72149" b="61738"/>
          <a:stretch/>
        </p:blipFill>
        <p:spPr>
          <a:xfrm>
            <a:off x="1770120" y="3460680"/>
            <a:ext cx="752400" cy="50184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" descr="C:\Users\wolfe\Desktop\10_22_2010 PI 567115 B brown seeds collection.jpg"/>
          <p:cNvPicPr/>
          <p:nvPr/>
        </p:nvPicPr>
        <p:blipFill>
          <a:blip r:embed="rId15"/>
          <a:srcRect l="3387" t="41520" r="69528" b="21689"/>
          <a:stretch/>
        </p:blipFill>
        <p:spPr>
          <a:xfrm>
            <a:off x="1770120" y="2106720"/>
            <a:ext cx="752400" cy="5508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5" descr="C:\Users\wolfe\Desktop\10_29_2010 PI 567115 B brown seeds collection.jpg"/>
          <p:cNvPicPr/>
          <p:nvPr/>
        </p:nvPicPr>
        <p:blipFill>
          <a:blip r:embed="rId16"/>
          <a:srcRect l="67044" t="14122" r="0" b="48362"/>
          <a:stretch/>
        </p:blipFill>
        <p:spPr>
          <a:xfrm>
            <a:off x="2657520" y="2792520"/>
            <a:ext cx="828720" cy="531720"/>
          </a:xfrm>
          <a:prstGeom prst="rect">
            <a:avLst/>
          </a:prstGeom>
          <a:ln w="0">
            <a:noFill/>
          </a:ln>
        </p:spPr>
      </p:pic>
      <p:sp>
        <p:nvSpPr>
          <p:cNvPr id="79" name="TextBox 1"/>
          <p:cNvSpPr/>
          <p:nvPr/>
        </p:nvSpPr>
        <p:spPr>
          <a:xfrm>
            <a:off x="1770120" y="5326200"/>
            <a:ext cx="309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Additional file 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9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5T15:06:37Z</dcterms:created>
  <dc:creator>Gillman, Jason D.</dc:creator>
  <dc:description/>
  <dc:language>en-US</dc:language>
  <cp:lastModifiedBy>Gillman, Jason D.</cp:lastModifiedBy>
  <cp:lastPrinted>2011-10-25T18:34:49Z</cp:lastPrinted>
  <dcterms:modified xsi:type="dcterms:W3CDTF">2011-11-01T21:45:45Z</dcterms:modified>
  <cp:revision>79</cp:revision>
  <dc:subject/>
  <dc:title>PowerPoint Presentation</dc:title>
</cp:coreProperties>
</file>